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4445">
          <p15:clr>
            <a:srgbClr val="A4A3A4"/>
          </p15:clr>
        </p15:guide>
        <p15:guide id="2" pos="254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B93"/>
    <a:srgbClr val="FFC8C5"/>
    <a:srgbClr val="FF3300"/>
    <a:srgbClr val="F6882E"/>
    <a:srgbClr val="FAB8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1594" autoAdjust="0"/>
    <p:restoredTop sz="99815" autoAdjust="0"/>
  </p:normalViewPr>
  <p:slideViewPr>
    <p:cSldViewPr showGuides="1">
      <p:cViewPr>
        <p:scale>
          <a:sx n="50" d="100"/>
          <a:sy n="50" d="100"/>
        </p:scale>
        <p:origin x="-2274" y="-162"/>
      </p:cViewPr>
      <p:guideLst>
        <p:guide orient="horz" pos="4445"/>
        <p:guide pos="254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7519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31009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47637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1899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4486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1152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154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09232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95299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4573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057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9640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0748" y="6524887"/>
            <a:ext cx="1565906" cy="16094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1842" y="4688683"/>
            <a:ext cx="1551684" cy="15947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80628" y="6660"/>
            <a:ext cx="7344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S3 </a:t>
            </a:r>
            <a:r>
              <a:rPr lang="es-ES" b="1" dirty="0" err="1" smtClean="0"/>
              <a:t>Fig</a:t>
            </a:r>
            <a:endParaRPr lang="es-ES" b="1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2091" y="2497541"/>
            <a:ext cx="1656184" cy="15608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865626" y="2245432"/>
            <a:ext cx="1371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Gated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on</a:t>
            </a:r>
            <a:r>
              <a:rPr lang="es-ES" sz="1400" b="1" dirty="0" smtClean="0"/>
              <a:t> B </a:t>
            </a:r>
            <a:r>
              <a:rPr lang="es-ES" sz="1400" b="1" dirty="0" err="1" smtClean="0"/>
              <a:t>cells</a:t>
            </a:r>
            <a:endParaRPr lang="en-GB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1304764" y="4485784"/>
            <a:ext cx="137185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Gated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on</a:t>
            </a:r>
            <a:r>
              <a:rPr lang="es-ES" sz="1400" b="1" dirty="0" smtClean="0"/>
              <a:t> B </a:t>
            </a:r>
            <a:r>
              <a:rPr lang="es-ES" sz="1400" b="1" dirty="0" err="1" smtClean="0"/>
              <a:t>cells</a:t>
            </a:r>
            <a:endParaRPr lang="en-GB" sz="1400" b="1" dirty="0"/>
          </a:p>
        </p:txBody>
      </p:sp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3016" y="6524887"/>
            <a:ext cx="1656184" cy="1647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3016" y="4688683"/>
            <a:ext cx="1656184" cy="1647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3448074" y="4485784"/>
            <a:ext cx="2322431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Gated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on</a:t>
            </a:r>
            <a:r>
              <a:rPr lang="es-ES" sz="1400" b="1" dirty="0" smtClean="0"/>
              <a:t> CD19</a:t>
            </a:r>
            <a:r>
              <a:rPr lang="es-ES" sz="1400" b="1" baseline="30000" dirty="0" smtClean="0"/>
              <a:t>+</a:t>
            </a:r>
            <a:r>
              <a:rPr lang="es-ES" sz="1400" b="1" dirty="0" smtClean="0"/>
              <a:t>CD24</a:t>
            </a:r>
            <a:r>
              <a:rPr lang="es-ES" sz="1400" b="1" baseline="30000" dirty="0" smtClean="0"/>
              <a:t>hi</a:t>
            </a:r>
            <a:r>
              <a:rPr lang="es-ES" sz="1400" b="1" dirty="0" smtClean="0"/>
              <a:t>CD38</a:t>
            </a:r>
            <a:r>
              <a:rPr lang="es-ES" sz="1400" b="1" baseline="30000" dirty="0" smtClean="0"/>
              <a:t>hi</a:t>
            </a:r>
            <a:endParaRPr lang="en-GB" sz="1400" b="1" baseline="30000" dirty="0"/>
          </a:p>
        </p:txBody>
      </p:sp>
      <p:sp>
        <p:nvSpPr>
          <p:cNvPr id="29" name="TextBox 28"/>
          <p:cNvSpPr txBox="1"/>
          <p:nvPr/>
        </p:nvSpPr>
        <p:spPr>
          <a:xfrm>
            <a:off x="1313102" y="6334672"/>
            <a:ext cx="1371850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Gated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on</a:t>
            </a:r>
            <a:r>
              <a:rPr lang="es-ES" sz="1400" b="1" dirty="0" smtClean="0"/>
              <a:t> B </a:t>
            </a:r>
            <a:r>
              <a:rPr lang="es-ES" sz="1400" b="1" dirty="0" err="1" smtClean="0"/>
              <a:t>cells</a:t>
            </a:r>
            <a:endParaRPr lang="en-GB" sz="14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3473722" y="6334672"/>
            <a:ext cx="228876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Gated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on</a:t>
            </a:r>
            <a:r>
              <a:rPr lang="es-ES" sz="1400" b="1" dirty="0" smtClean="0"/>
              <a:t> CD19</a:t>
            </a:r>
            <a:r>
              <a:rPr lang="es-ES" sz="1400" b="1" baseline="30000" dirty="0" smtClean="0"/>
              <a:t>+</a:t>
            </a:r>
            <a:r>
              <a:rPr lang="es-ES" sz="1400" b="1" dirty="0" smtClean="0"/>
              <a:t>CD24</a:t>
            </a:r>
            <a:r>
              <a:rPr lang="es-ES" sz="1400" b="1" baseline="30000" dirty="0" smtClean="0"/>
              <a:t>hi</a:t>
            </a:r>
            <a:r>
              <a:rPr lang="es-ES" sz="1400" b="1" dirty="0" smtClean="0"/>
              <a:t>CD27</a:t>
            </a:r>
            <a:r>
              <a:rPr lang="es-ES" sz="1400" b="1" baseline="30000" dirty="0" smtClean="0"/>
              <a:t>+</a:t>
            </a:r>
            <a:endParaRPr lang="en-GB" sz="1400" b="1" baseline="30000" dirty="0"/>
          </a:p>
        </p:txBody>
      </p:sp>
      <p:sp>
        <p:nvSpPr>
          <p:cNvPr id="31" name="TextBox 30"/>
          <p:cNvSpPr txBox="1"/>
          <p:nvPr/>
        </p:nvSpPr>
        <p:spPr>
          <a:xfrm>
            <a:off x="1160748" y="2263653"/>
            <a:ext cx="16716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Gated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on</a:t>
            </a:r>
            <a:r>
              <a:rPr lang="es-ES" sz="1400" b="1" dirty="0" smtClean="0"/>
              <a:t> living </a:t>
            </a:r>
            <a:r>
              <a:rPr lang="es-ES" sz="1400" b="1" dirty="0" err="1" smtClean="0"/>
              <a:t>cells</a:t>
            </a:r>
            <a:endParaRPr lang="en-GB" sz="14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769282" y="223174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769282" y="439751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109542" y="2195736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003549" y="4469525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(i)</a:t>
            </a:r>
            <a:endParaRPr lang="en-GB" sz="14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1003586" y="6300192"/>
            <a:ext cx="3866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(ii)</a:t>
            </a:r>
            <a:endParaRPr lang="en-GB" sz="14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3038054" y="4397517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E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3212976" y="4469525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(i)</a:t>
            </a:r>
            <a:endParaRPr lang="en-GB" sz="14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3213013" y="6300192"/>
            <a:ext cx="3866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(ii)</a:t>
            </a:r>
            <a:endParaRPr lang="en-GB" sz="1400" b="1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4744" y="2497541"/>
            <a:ext cx="1591100" cy="15997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8" name="TextBox 47"/>
          <p:cNvSpPr txBox="1"/>
          <p:nvPr/>
        </p:nvSpPr>
        <p:spPr>
          <a:xfrm>
            <a:off x="759664" y="46754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2736" y="596526"/>
            <a:ext cx="1706034" cy="16712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9020" y="687318"/>
            <a:ext cx="1671218" cy="1584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5" name="Straight Arrow Connector 14"/>
          <p:cNvCxnSpPr/>
          <p:nvPr/>
        </p:nvCxnSpPr>
        <p:spPr>
          <a:xfrm>
            <a:off x="2600908" y="1763688"/>
            <a:ext cx="1008112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872716" y="71500"/>
            <a:ext cx="13356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PBMCs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labeling</a:t>
            </a:r>
            <a:endParaRPr lang="en-US" sz="1400" b="1" dirty="0"/>
          </a:p>
        </p:txBody>
      </p:sp>
      <p:cxnSp>
        <p:nvCxnSpPr>
          <p:cNvPr id="38" name="Straight Arrow Connector 37"/>
          <p:cNvCxnSpPr/>
          <p:nvPr/>
        </p:nvCxnSpPr>
        <p:spPr>
          <a:xfrm flipH="1">
            <a:off x="2744924" y="1943708"/>
            <a:ext cx="864096" cy="612068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>
            <a:off x="2564904" y="3419872"/>
            <a:ext cx="1008112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>
            <a:off x="2528900" y="5508104"/>
            <a:ext cx="1008112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/>
          <p:nvPr/>
        </p:nvCxnSpPr>
        <p:spPr>
          <a:xfrm>
            <a:off x="2492896" y="7164288"/>
            <a:ext cx="1008112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/>
          <p:nvPr/>
        </p:nvCxnSpPr>
        <p:spPr>
          <a:xfrm rot="5400000">
            <a:off x="1808820" y="4031940"/>
            <a:ext cx="1008112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976785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00</TotalTime>
  <Words>44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jorie Pion</dc:creator>
  <cp:lastModifiedBy>Marjorie Pion</cp:lastModifiedBy>
  <cp:revision>300</cp:revision>
  <dcterms:created xsi:type="dcterms:W3CDTF">2016-12-20T15:13:27Z</dcterms:created>
  <dcterms:modified xsi:type="dcterms:W3CDTF">2018-12-29T17:00:52Z</dcterms:modified>
</cp:coreProperties>
</file>